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D6E14D-9784-4EEF-975C-85A3B94D277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8F6413-CDDB-4780-88BC-1A298A9C240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17D1DC-EB19-4240-9EDA-8130BA2E7E2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0B943B-7A47-4477-988B-F166C5B51CA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94D9CB-C27D-4C0A-9674-31F89FE82C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FF25B9-AAEE-4871-AF8D-7E00DFBF469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3009D0-62C6-4BCF-A074-BA70C29004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81D82C-6A91-4054-8735-E4D981F3F9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2A46D9-602A-4AC8-BB3D-330759BD23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506A38-7495-4EC9-95E8-A9A1617259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FBD604-E27F-418A-AA3C-02F6662571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D9F333-C15C-4D86-8549-F075CD77DF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SG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F056F37-4214-4671-A40A-D81FC6736B9A}" type="slidenum">
              <a:rPr b="0" lang="en-SG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"/>
          <p:cNvSpPr/>
          <p:nvPr/>
        </p:nvSpPr>
        <p:spPr>
          <a:xfrm>
            <a:off x="6480" y="0"/>
            <a:ext cx="1322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uppl. Fig.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5"/>
          <p:cNvGrpSpPr/>
          <p:nvPr/>
        </p:nvGrpSpPr>
        <p:grpSpPr>
          <a:xfrm>
            <a:off x="142920" y="214200"/>
            <a:ext cx="8143560" cy="6228000"/>
            <a:chOff x="142920" y="214200"/>
            <a:chExt cx="8143560" cy="6228000"/>
          </a:xfrm>
        </p:grpSpPr>
        <p:sp>
          <p:nvSpPr>
            <p:cNvPr id="43" name="Freeform 6"/>
            <p:cNvSpPr/>
            <p:nvPr/>
          </p:nvSpPr>
          <p:spPr>
            <a:xfrm>
              <a:off x="142920" y="678960"/>
              <a:ext cx="7790040" cy="5763240"/>
            </a:xfrm>
            <a:prstGeom prst="pie">
              <a:avLst/>
            </a:prstGeom>
            <a:solidFill>
              <a:srgbClr val="fdeada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4" name="Group 2"/>
            <p:cNvGrpSpPr/>
            <p:nvPr/>
          </p:nvGrpSpPr>
          <p:grpSpPr>
            <a:xfrm>
              <a:off x="964440" y="214200"/>
              <a:ext cx="7322040" cy="5856480"/>
              <a:chOff x="964440" y="214200"/>
              <a:chExt cx="7322040" cy="5856480"/>
            </a:xfrm>
          </p:grpSpPr>
          <p:sp>
            <p:nvSpPr>
              <p:cNvPr id="45" name="Line 14"/>
              <p:cNvSpPr/>
              <p:nvPr/>
            </p:nvSpPr>
            <p:spPr>
              <a:xfrm flipV="1">
                <a:off x="4560840" y="2236320"/>
                <a:ext cx="0" cy="1504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Line 14"/>
              <p:cNvSpPr/>
              <p:nvPr/>
            </p:nvSpPr>
            <p:spPr>
              <a:xfrm flipV="1">
                <a:off x="4560840" y="1705680"/>
                <a:ext cx="0" cy="1504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7" name="Group 58"/>
              <p:cNvGrpSpPr/>
              <p:nvPr/>
            </p:nvGrpSpPr>
            <p:grpSpPr>
              <a:xfrm>
                <a:off x="964440" y="214200"/>
                <a:ext cx="7322040" cy="5856480"/>
                <a:chOff x="964440" y="214200"/>
                <a:chExt cx="7322040" cy="5856480"/>
              </a:xfrm>
            </p:grpSpPr>
            <p:grpSp>
              <p:nvGrpSpPr>
                <p:cNvPr id="48" name="Group 83"/>
                <p:cNvGrpSpPr/>
                <p:nvPr/>
              </p:nvGrpSpPr>
              <p:grpSpPr>
                <a:xfrm>
                  <a:off x="964440" y="214200"/>
                  <a:ext cx="7322040" cy="5856480"/>
                  <a:chOff x="964440" y="214200"/>
                  <a:chExt cx="7322040" cy="5856480"/>
                </a:xfrm>
              </p:grpSpPr>
              <p:sp>
                <p:nvSpPr>
                  <p:cNvPr id="49" name="AutoShape 4"/>
                  <p:cNvSpPr/>
                  <p:nvPr/>
                </p:nvSpPr>
                <p:spPr>
                  <a:xfrm>
                    <a:off x="3958200" y="3214080"/>
                    <a:ext cx="1274400" cy="416160"/>
                  </a:xfrm>
                  <a:prstGeom prst="roundRect">
                    <a:avLst>
                      <a:gd name="adj" fmla="val 16667"/>
                    </a:avLst>
                  </a:prstGeom>
                  <a:solidFill>
                    <a:srgbClr val="0d0d0d"/>
                  </a:solidFill>
                  <a:ln w="9360">
                    <a:solidFill>
                      <a:srgbClr val="0000ff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GB" sz="2400" spc="-1" strike="noStrike">
                        <a:solidFill>
                          <a:srgbClr val="ffffff"/>
                        </a:solidFill>
                        <a:latin typeface="Arial"/>
                      </a:rPr>
                      <a:t>Profilin</a:t>
                    </a: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50" name="Group 80"/>
                  <p:cNvGrpSpPr/>
                  <p:nvPr/>
                </p:nvGrpSpPr>
                <p:grpSpPr>
                  <a:xfrm>
                    <a:off x="5402160" y="1277280"/>
                    <a:ext cx="2884320" cy="3939120"/>
                    <a:chOff x="5402160" y="1277280"/>
                    <a:chExt cx="2884320" cy="3939120"/>
                  </a:xfrm>
                </p:grpSpPr>
                <p:sp>
                  <p:nvSpPr>
                    <p:cNvPr id="51" name="AutoShape 6"/>
                    <p:cNvSpPr/>
                    <p:nvPr/>
                  </p:nvSpPr>
                  <p:spPr>
                    <a:xfrm>
                      <a:off x="5894640" y="3241080"/>
                      <a:ext cx="1442160" cy="574920"/>
                    </a:xfrm>
                    <a:prstGeom prst="flowChartMagneticDisk">
                      <a:avLst/>
                    </a:prstGeom>
                    <a:solidFill>
                      <a:srgbClr val="a6a6a6"/>
                    </a:solidFill>
                    <a:ln w="0">
                      <a:noFill/>
                    </a:ln>
                    <a:effectLst>
                      <a:outerShdw dist="20160" dir="5400000" blurRad="0" rotWithShape="0">
                        <a:srgbClr val="000000">
                          <a:alpha val="38000"/>
                        </a:srgbClr>
                      </a:outerShdw>
                    </a:effectLst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-62280" bIns="21204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ctin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ssembly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2" name="Line 27"/>
                    <p:cNvSpPr/>
                    <p:nvPr/>
                  </p:nvSpPr>
                  <p:spPr>
                    <a:xfrm>
                      <a:off x="5402160" y="3412080"/>
                      <a:ext cx="335160" cy="1080"/>
                    </a:xfrm>
                    <a:prstGeom prst="line">
                      <a:avLst/>
                    </a:prstGeom>
                    <a:ln w="28440">
                      <a:solidFill>
                        <a:srgbClr val="000000"/>
                      </a:solidFill>
                      <a:miter/>
                      <a:tailEnd len="med" type="triangle" w="med"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5720" bIns="-457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3" name="AutoShape 7"/>
                    <p:cNvSpPr/>
                    <p:nvPr/>
                  </p:nvSpPr>
                  <p:spPr>
                    <a:xfrm rot="5400000">
                      <a:off x="5893560" y="2823480"/>
                      <a:ext cx="3939120" cy="846360"/>
                    </a:xfrm>
                    <a:prstGeom prst="diamond">
                      <a:avLst/>
                    </a:prstGeom>
                    <a:gradFill rotWithShape="0">
                      <a:gsLst>
                        <a:gs pos="0">
                          <a:srgbClr val="cacaca"/>
                        </a:gs>
                        <a:gs pos="100000">
                          <a:srgbClr val="eeeeee"/>
                        </a:gs>
                      </a:gsLst>
                      <a:lin ang="0"/>
                    </a:gradFill>
                    <a:ln w="0">
                      <a:noFill/>
                    </a:ln>
                    <a:effectLst>
                      <a:outerShdw dist="20160" dir="5400000" blurRad="0" rotWithShape="0">
                        <a:srgbClr val="000000">
                          <a:alpha val="38000"/>
                        </a:srgbClr>
                      </a:outerShdw>
                    </a:effectLst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ellular Architecture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54" name="Group 79"/>
                  <p:cNvGrpSpPr/>
                  <p:nvPr/>
                </p:nvGrpSpPr>
                <p:grpSpPr>
                  <a:xfrm>
                    <a:off x="1610640" y="214200"/>
                    <a:ext cx="5590080" cy="2975400"/>
                    <a:chOff x="1610640" y="214200"/>
                    <a:chExt cx="5590080" cy="2975400"/>
                  </a:xfrm>
                </p:grpSpPr>
                <p:sp>
                  <p:nvSpPr>
                    <p:cNvPr id="55" name="AutoShape 3"/>
                    <p:cNvSpPr/>
                    <p:nvPr/>
                  </p:nvSpPr>
                  <p:spPr>
                    <a:xfrm>
                      <a:off x="4159440" y="2395080"/>
                      <a:ext cx="803880" cy="441360"/>
                    </a:xfrm>
                    <a:prstGeom prst="can">
                      <a:avLst>
                        <a:gd name="adj" fmla="val 25000"/>
                      </a:avLst>
                    </a:prstGeom>
                    <a:solidFill>
                      <a:srgbClr val="4bacc6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IP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6" name="Line 14"/>
                    <p:cNvSpPr/>
                    <p:nvPr/>
                  </p:nvSpPr>
                  <p:spPr>
                    <a:xfrm flipV="1">
                      <a:off x="4560840" y="2900880"/>
                      <a:ext cx="0" cy="288720"/>
                    </a:xfrm>
                    <a:prstGeom prst="line">
                      <a:avLst/>
                    </a:prstGeom>
                    <a:ln w="28440">
                      <a:solidFill>
                        <a:srgbClr val="000000"/>
                      </a:solidFill>
                      <a:miter/>
                      <a:tailEnd len="med" type="triangle" w="med"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7" name="AutoShape 44"/>
                    <p:cNvSpPr/>
                    <p:nvPr/>
                  </p:nvSpPr>
                  <p:spPr>
                    <a:xfrm>
                      <a:off x="1610640" y="1379880"/>
                      <a:ext cx="803880" cy="609840"/>
                    </a:xfrm>
                    <a:prstGeom prst="flowChartMagneticDisk">
                      <a:avLst/>
                    </a:prstGeom>
                    <a:solidFill>
                      <a:srgbClr val="4bacc6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1828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P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8" name="Line 48"/>
                    <p:cNvSpPr/>
                    <p:nvPr/>
                  </p:nvSpPr>
                  <p:spPr>
                    <a:xfrm flipH="1" flipV="1">
                      <a:off x="3487680" y="1787760"/>
                      <a:ext cx="601920" cy="449280"/>
                    </a:xfrm>
                    <a:prstGeom prst="line">
                      <a:avLst/>
                    </a:prstGeom>
                    <a:ln w="28440">
                      <a:solidFill>
                        <a:srgbClr val="000000"/>
                      </a:solidFill>
                      <a:miter/>
                      <a:tailEnd len="med" type="triangle" w="med"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9" name="AutoShape 49"/>
                    <p:cNvSpPr/>
                    <p:nvPr/>
                  </p:nvSpPr>
                  <p:spPr>
                    <a:xfrm>
                      <a:off x="2615760" y="1379880"/>
                      <a:ext cx="872280" cy="609840"/>
                    </a:xfrm>
                    <a:prstGeom prst="flowChartMagneticDisk">
                      <a:avLst/>
                    </a:prstGeom>
                    <a:solidFill>
                      <a:srgbClr val="4bacc6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1828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aPCCP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0" name="Line 50"/>
                    <p:cNvSpPr/>
                    <p:nvPr/>
                  </p:nvSpPr>
                  <p:spPr>
                    <a:xfrm>
                      <a:off x="2414520" y="1719720"/>
                      <a:ext cx="200880" cy="0"/>
                    </a:xfrm>
                    <a:prstGeom prst="line">
                      <a:avLst/>
                    </a:prstGeom>
                    <a:ln w="284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1" name="Line 48"/>
                    <p:cNvSpPr/>
                    <p:nvPr/>
                  </p:nvSpPr>
                  <p:spPr>
                    <a:xfrm flipV="1">
                      <a:off x="5030640" y="1841760"/>
                      <a:ext cx="597960" cy="421200"/>
                    </a:xfrm>
                    <a:prstGeom prst="line">
                      <a:avLst/>
                    </a:prstGeom>
                    <a:ln w="28440">
                      <a:solidFill>
                        <a:srgbClr val="000000"/>
                      </a:solidFill>
                      <a:miter/>
                      <a:tailEnd len="med" type="triangle" w="med"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2" name="AutoShape 7"/>
                    <p:cNvSpPr/>
                    <p:nvPr/>
                  </p:nvSpPr>
                  <p:spPr>
                    <a:xfrm>
                      <a:off x="1946160" y="214200"/>
                      <a:ext cx="5164200" cy="927720"/>
                    </a:xfrm>
                    <a:prstGeom prst="diamond">
                      <a:avLst/>
                    </a:prstGeom>
                    <a:gradFill rotWithShape="0">
                      <a:gsLst>
                        <a:gs pos="0">
                          <a:srgbClr val="97d4eb"/>
                        </a:gs>
                        <a:gs pos="100000">
                          <a:srgbClr val="e0f1f8"/>
                        </a:gs>
                      </a:gsLst>
                      <a:lin ang="5400000"/>
                    </a:gra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gnalling Cascade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3" name="AutoShape 44"/>
                    <p:cNvSpPr/>
                    <p:nvPr/>
                  </p:nvSpPr>
                  <p:spPr>
                    <a:xfrm>
                      <a:off x="2735640" y="2125800"/>
                      <a:ext cx="1087920" cy="371880"/>
                    </a:xfrm>
                    <a:prstGeom prst="flowChartMagneticDisk">
                      <a:avLst/>
                    </a:prstGeom>
                    <a:solidFill>
                      <a:srgbClr val="4bacc6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9144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ho GTPas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4" name="AutoShape 49"/>
                    <p:cNvSpPr/>
                    <p:nvPr/>
                  </p:nvSpPr>
                  <p:spPr>
                    <a:xfrm>
                      <a:off x="5701320" y="1310400"/>
                      <a:ext cx="1499400" cy="612000"/>
                    </a:xfrm>
                    <a:prstGeom prst="flowChartMagneticDisk">
                      <a:avLst/>
                    </a:prstGeom>
                    <a:solidFill>
                      <a:srgbClr val="4bacc6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1828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lin Rich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tein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65" name="Group 78"/>
                  <p:cNvGrpSpPr/>
                  <p:nvPr/>
                </p:nvGrpSpPr>
                <p:grpSpPr>
                  <a:xfrm>
                    <a:off x="964440" y="1396440"/>
                    <a:ext cx="2925360" cy="3939480"/>
                    <a:chOff x="964440" y="1396440"/>
                    <a:chExt cx="2925360" cy="3939480"/>
                  </a:xfrm>
                </p:grpSpPr>
                <p:sp>
                  <p:nvSpPr>
                    <p:cNvPr id="66" name="AutoShape 5"/>
                    <p:cNvSpPr/>
                    <p:nvPr/>
                  </p:nvSpPr>
                  <p:spPr>
                    <a:xfrm>
                      <a:off x="2303640" y="2697120"/>
                      <a:ext cx="806040" cy="448920"/>
                    </a:xfrm>
                    <a:prstGeom prst="flowChartMagneticDisk">
                      <a:avLst/>
                    </a:prstGeom>
                    <a:gradFill rotWithShape="0">
                      <a:gsLst>
                        <a:gs pos="0">
                          <a:srgbClr val="769535"/>
                        </a:gs>
                        <a:gs pos="100000">
                          <a:srgbClr val="9cc746"/>
                        </a:gs>
                      </a:gsLst>
                      <a:lin ang="16200000"/>
                    </a:gradFill>
                    <a:ln w="9360">
                      <a:solidFill>
                        <a:srgbClr val="98b954"/>
                      </a:solidFill>
                      <a:miter/>
                    </a:ln>
                    <a:effectLst>
                      <a:outerShdw dist="23040" dir="5400000" blurRad="0" rotWithShape="0">
                        <a:srgbClr val="000000">
                          <a:alpha val="35000"/>
                        </a:srgbClr>
                      </a:outerShdw>
                    </a:effectLst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1828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U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7" name="AutoShape 43"/>
                    <p:cNvSpPr/>
                    <p:nvPr/>
                  </p:nvSpPr>
                  <p:spPr>
                    <a:xfrm>
                      <a:off x="2288880" y="3436920"/>
                      <a:ext cx="804240" cy="456840"/>
                    </a:xfrm>
                    <a:prstGeom prst="flowChartMagneticDisk">
                      <a:avLst/>
                    </a:prstGeom>
                    <a:gradFill rotWithShape="0">
                      <a:gsLst>
                        <a:gs pos="0">
                          <a:srgbClr val="769535"/>
                        </a:gs>
                        <a:gs pos="100000">
                          <a:srgbClr val="9cc746"/>
                        </a:gs>
                      </a:gsLst>
                      <a:lin ang="16200000"/>
                    </a:gradFill>
                    <a:ln w="9360">
                      <a:solidFill>
                        <a:srgbClr val="98b954"/>
                      </a:solidFill>
                      <a:miter/>
                    </a:ln>
                    <a:effectLst>
                      <a:outerShdw dist="23040" dir="5400000" blurRad="0" rotWithShape="0">
                        <a:srgbClr val="000000">
                          <a:alpha val="35000"/>
                        </a:srgbClr>
                      </a:outerShdw>
                    </a:effectLst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9144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LV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8" name="Curved Right Arrow 38"/>
                    <p:cNvSpPr/>
                    <p:nvPr/>
                  </p:nvSpPr>
                  <p:spPr>
                    <a:xfrm>
                      <a:off x="1877400" y="2875320"/>
                      <a:ext cx="376200" cy="876960"/>
                    </a:xfrm>
                    <a:custGeom>
                      <a:avLst/>
                      <a:gdLst>
                        <a:gd name="textAreaLeft" fmla="*/ 50400 w 376200"/>
                        <a:gd name="textAreaRight" fmla="*/ 325800 w 376200"/>
                        <a:gd name="textAreaTop" fmla="*/ 192600 h 876960"/>
                        <a:gd name="textAreaBottom" fmla="*/ 666360 h 876960"/>
                      </a:gdLst>
                      <a:ahLst/>
                      <a:rect l="textAreaLeft" t="textAreaTop" r="textAreaRight" b="textAreaBottom"/>
                      <a:pathLst>
                        <a:path w="21600" h="21600">
                          <a:moveTo>
                            <a:pt x="21600" y="0"/>
                          </a:moveTo>
                          <a:arcTo wR="21600" hR="9494" stAng="-5400000" swAng="-5400000"/>
                          <a:lnTo>
                            <a:pt x="0" y="11663"/>
                          </a:lnTo>
                          <a:arcTo wR="21600" hR="9494" stAng="10800000" swAng="-4656211"/>
                          <a:lnTo>
                            <a:pt x="19523" y="21556"/>
                          </a:lnTo>
                          <a:lnTo>
                            <a:pt x="21600" y="20072"/>
                          </a:lnTo>
                          <a:lnTo>
                            <a:pt x="19523" y="18499"/>
                          </a:lnTo>
                          <a:lnTo>
                            <a:pt x="19523" y="18943"/>
                          </a:lnTo>
                          <a:arcTo wR="21600" hR="9494" stAng="6143789" swAng="4482618"/>
                          <a:lnTo>
                            <a:pt x="141" y="10578"/>
                          </a:lnTo>
                          <a:arcTo wR="21600" hR="9494" stAng="-10626407" swAng="5226407"/>
                          <a:close/>
                        </a:path>
                        <a:path fill="darkenLess" w="21600" h="21600">
                          <a:moveTo>
                            <a:pt x="21600" y="0"/>
                          </a:moveTo>
                          <a:arcTo wR="21600" hR="9494" stAng="-5400000" swAng="-5400000"/>
                          <a:lnTo>
                            <a:pt x="0" y="9494"/>
                          </a:lnTo>
                          <a:arcTo wR="21600" hR="9494" stAng="10800000" swAng="-173593"/>
                          <a:lnTo>
                            <a:pt x="141" y="10578"/>
                          </a:lnTo>
                          <a:arcTo wR="21600" hR="9494" stAng="-10626407" swAng="5226407"/>
                          <a:close/>
                        </a:path>
                      </a:pathLst>
                    </a:custGeom>
                    <a:solidFill>
                      <a:srgbClr val="0000ff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9" name="Curved Right Arrow 39"/>
                    <p:cNvSpPr/>
                    <p:nvPr/>
                  </p:nvSpPr>
                  <p:spPr>
                    <a:xfrm flipH="1" flipV="1">
                      <a:off x="3151800" y="2875320"/>
                      <a:ext cx="402120" cy="876960"/>
                    </a:xfrm>
                    <a:custGeom>
                      <a:avLst/>
                      <a:gdLst>
                        <a:gd name="textAreaLeft" fmla="*/ 53640 w 402120"/>
                        <a:gd name="textAreaRight" fmla="*/ 348480 w 402120"/>
                        <a:gd name="textAreaTop" fmla="*/ 191160 h 876960"/>
                        <a:gd name="textAreaBottom" fmla="*/ 667440 h 876960"/>
                      </a:gdLst>
                      <a:ahLst/>
                      <a:rect l="textAreaLeft" t="textAreaTop" r="textAreaRight" b="textAreaBottom"/>
                      <a:pathLst>
                        <a:path w="21600" h="21600">
                          <a:moveTo>
                            <a:pt x="21600" y="0"/>
                          </a:moveTo>
                          <a:arcTo wR="21600" hR="9404" stAng="-5400000" swAng="-5400000"/>
                          <a:lnTo>
                            <a:pt x="0" y="11723"/>
                          </a:lnTo>
                          <a:arcTo wR="21600" hR="9404" stAng="10800000" swAng="-4649316"/>
                          <a:lnTo>
                            <a:pt x="19523" y="21556"/>
                          </a:lnTo>
                          <a:lnTo>
                            <a:pt x="21600" y="19967"/>
                          </a:lnTo>
                          <a:lnTo>
                            <a:pt x="19523" y="18289"/>
                          </a:lnTo>
                          <a:lnTo>
                            <a:pt x="19523" y="18763"/>
                          </a:lnTo>
                          <a:arcTo wR="21600" hR="9404" stAng="6150684" swAng="4463538"/>
                          <a:lnTo>
                            <a:pt x="165" y="10563"/>
                          </a:lnTo>
                          <a:arcTo wR="21600" hR="9404" stAng="-10614222" swAng="5214222"/>
                          <a:close/>
                        </a:path>
                        <a:path fill="darkenLess" w="21600" h="21600">
                          <a:moveTo>
                            <a:pt x="21600" y="0"/>
                          </a:moveTo>
                          <a:arcTo wR="21600" hR="9404" stAng="-5400000" swAng="-5400000"/>
                          <a:lnTo>
                            <a:pt x="0" y="9404"/>
                          </a:lnTo>
                          <a:arcTo wR="21600" hR="9404" stAng="10800000" swAng="-185778"/>
                          <a:lnTo>
                            <a:pt x="165" y="10563"/>
                          </a:lnTo>
                          <a:arcTo wR="21600" hR="9404" stAng="-10614222" swAng="5214222"/>
                          <a:close/>
                        </a:path>
                      </a:pathLst>
                    </a:custGeom>
                    <a:solidFill>
                      <a:srgbClr val="0000ff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0" name="AutoShape 7"/>
                    <p:cNvSpPr/>
                    <p:nvPr/>
                  </p:nvSpPr>
                  <p:spPr>
                    <a:xfrm rot="5400000">
                      <a:off x="-619560" y="2980440"/>
                      <a:ext cx="3939480" cy="771120"/>
                    </a:xfrm>
                    <a:prstGeom prst="diamond">
                      <a:avLst/>
                    </a:prstGeom>
                    <a:gradFill rotWithShape="0">
                      <a:gsLst>
                        <a:gs pos="0">
                          <a:srgbClr val="769535"/>
                        </a:gs>
                        <a:gs pos="100000">
                          <a:srgbClr val="9cc746"/>
                        </a:gs>
                      </a:gsLst>
                      <a:lin ang="0"/>
                    </a:gradFill>
                    <a:ln w="0">
                      <a:noFill/>
                    </a:ln>
                    <a:effectLst>
                      <a:outerShdw dist="23040" dir="5400000" blurRad="0" rotWithShape="0">
                        <a:srgbClr val="000000">
                          <a:alpha val="35000"/>
                        </a:srgbClr>
                      </a:outerShdw>
                    </a:effectLst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9144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ristem Determinancy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1" name="Line 27"/>
                    <p:cNvSpPr/>
                    <p:nvPr/>
                  </p:nvSpPr>
                  <p:spPr>
                    <a:xfrm flipH="1">
                      <a:off x="3621600" y="3418200"/>
                      <a:ext cx="268200" cy="0"/>
                    </a:xfrm>
                    <a:prstGeom prst="line">
                      <a:avLst/>
                    </a:prstGeom>
                    <a:ln w="28440">
                      <a:solidFill>
                        <a:srgbClr val="000000"/>
                      </a:solidFill>
                      <a:miter/>
                      <a:tailEnd len="med" type="triangle" w="med"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2" name="Bent-Up Arrow 42"/>
                    <p:cNvSpPr/>
                    <p:nvPr/>
                  </p:nvSpPr>
                  <p:spPr>
                    <a:xfrm rot="19389000">
                      <a:off x="3399120" y="2629080"/>
                      <a:ext cx="407520" cy="294120"/>
                    </a:xfrm>
                    <a:prstGeom prst="pie">
                      <a:avLst/>
                    </a:prstGeom>
                    <a:noFill/>
                    <a:ln w="25560">
                      <a:solidFill>
                        <a:srgbClr val="7030a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4120" bIns="-2412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73" name="Group 82"/>
                  <p:cNvGrpSpPr/>
                  <p:nvPr/>
                </p:nvGrpSpPr>
                <p:grpSpPr>
                  <a:xfrm>
                    <a:off x="2165400" y="3688560"/>
                    <a:ext cx="4793760" cy="2382120"/>
                    <a:chOff x="2165400" y="3688560"/>
                    <a:chExt cx="4793760" cy="2382120"/>
                  </a:xfrm>
                </p:grpSpPr>
                <p:sp>
                  <p:nvSpPr>
                    <p:cNvPr id="74" name="Line 15"/>
                    <p:cNvSpPr/>
                    <p:nvPr/>
                  </p:nvSpPr>
                  <p:spPr>
                    <a:xfrm>
                      <a:off x="4560840" y="3688560"/>
                      <a:ext cx="0" cy="244440"/>
                    </a:xfrm>
                    <a:prstGeom prst="line">
                      <a:avLst/>
                    </a:prstGeom>
                    <a:ln w="28440">
                      <a:solidFill>
                        <a:srgbClr val="000000"/>
                      </a:solidFill>
                      <a:miter/>
                      <a:tailEnd len="med" type="triangle" w="med"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grpSp>
                  <p:nvGrpSpPr>
                    <p:cNvPr id="75" name="Group 81"/>
                    <p:cNvGrpSpPr/>
                    <p:nvPr/>
                  </p:nvGrpSpPr>
                  <p:grpSpPr>
                    <a:xfrm>
                      <a:off x="2165400" y="4389120"/>
                      <a:ext cx="4793760" cy="1681560"/>
                      <a:chOff x="2165400" y="4389120"/>
                      <a:chExt cx="4793760" cy="1681560"/>
                    </a:xfrm>
                  </p:grpSpPr>
                  <p:sp>
                    <p:nvSpPr>
                      <p:cNvPr id="76" name="AutoShape 20"/>
                      <p:cNvSpPr/>
                      <p:nvPr/>
                    </p:nvSpPr>
                    <p:spPr>
                      <a:xfrm>
                        <a:off x="2610000" y="4728600"/>
                        <a:ext cx="603720" cy="389520"/>
                      </a:xfrm>
                      <a:prstGeom prst="roundRect">
                        <a:avLst>
                          <a:gd name="adj" fmla="val 16667"/>
                        </a:avLst>
                      </a:prstGeom>
                      <a:gradFill rotWithShape="0">
                        <a:gsLst>
                          <a:gs pos="0">
                            <a:srgbClr val="fff200"/>
                          </a:gs>
                          <a:gs pos="100000">
                            <a:srgbClr val="4d0808"/>
                          </a:gs>
                        </a:gsLst>
                        <a:lin ang="4800000"/>
                      </a:gra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90000" rIns="90000" tIns="46800" bIns="46800" anchor="ctr">
                        <a:no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1" lang="en-GB" sz="1400" spc="-1" strike="noStrike">
                            <a:solidFill>
                              <a:srgbClr val="000000"/>
                            </a:solidFill>
                            <a:latin typeface="Calibri"/>
                          </a:rPr>
                          <a:t>AP1</a:t>
                        </a:r>
                        <a:endParaRPr b="0" lang="en-US" sz="1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77" name="Line 31"/>
                      <p:cNvSpPr/>
                      <p:nvPr/>
                    </p:nvSpPr>
                    <p:spPr>
                      <a:xfrm>
                        <a:off x="4622400" y="4389120"/>
                        <a:ext cx="0" cy="339480"/>
                      </a:xfrm>
                      <a:prstGeom prst="line">
                        <a:avLst/>
                      </a:prstGeom>
                      <a:ln w="28440">
                        <a:solidFill>
                          <a:srgbClr val="000000"/>
                        </a:solidFill>
                        <a:miter/>
                        <a:tailEnd len="med" type="triangle" w="med"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78" name="Line 34"/>
                      <p:cNvSpPr/>
                      <p:nvPr/>
                    </p:nvSpPr>
                    <p:spPr>
                      <a:xfrm>
                        <a:off x="2878200" y="4389120"/>
                        <a:ext cx="3354120" cy="0"/>
                      </a:xfrm>
                      <a:prstGeom prst="line">
                        <a:avLst/>
                      </a:prstGeom>
                      <a:ln w="2844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6800" bIns="-46800" anchor="ctr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79" name="Line 35"/>
                      <p:cNvSpPr/>
                      <p:nvPr/>
                    </p:nvSpPr>
                    <p:spPr>
                      <a:xfrm>
                        <a:off x="5427360" y="4389120"/>
                        <a:ext cx="0" cy="339480"/>
                      </a:xfrm>
                      <a:prstGeom prst="line">
                        <a:avLst/>
                      </a:prstGeom>
                      <a:ln w="28440">
                        <a:solidFill>
                          <a:srgbClr val="000000"/>
                        </a:solidFill>
                        <a:miter/>
                        <a:tailEnd len="med" type="triangle" w="med"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80" name="Line 36"/>
                      <p:cNvSpPr/>
                      <p:nvPr/>
                    </p:nvSpPr>
                    <p:spPr>
                      <a:xfrm>
                        <a:off x="6232320" y="4389120"/>
                        <a:ext cx="0" cy="339480"/>
                      </a:xfrm>
                      <a:prstGeom prst="line">
                        <a:avLst/>
                      </a:prstGeom>
                      <a:ln w="28440">
                        <a:solidFill>
                          <a:srgbClr val="000000"/>
                        </a:solidFill>
                        <a:miter/>
                        <a:tailEnd len="med" type="triangle" w="med"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81" name="Line 31"/>
                      <p:cNvSpPr/>
                      <p:nvPr/>
                    </p:nvSpPr>
                    <p:spPr>
                      <a:xfrm>
                        <a:off x="3683160" y="4389120"/>
                        <a:ext cx="1080" cy="331200"/>
                      </a:xfrm>
                      <a:prstGeom prst="line">
                        <a:avLst/>
                      </a:prstGeom>
                      <a:ln w="28440">
                        <a:solidFill>
                          <a:srgbClr val="000000"/>
                        </a:solidFill>
                        <a:miter/>
                        <a:tailEnd len="med" type="triangle" w="med"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82" name="Line 31"/>
                      <p:cNvSpPr/>
                      <p:nvPr/>
                    </p:nvSpPr>
                    <p:spPr>
                      <a:xfrm>
                        <a:off x="2878200" y="4397400"/>
                        <a:ext cx="1080" cy="331200"/>
                      </a:xfrm>
                      <a:prstGeom prst="line">
                        <a:avLst/>
                      </a:prstGeom>
                      <a:ln w="28440">
                        <a:solidFill>
                          <a:srgbClr val="000000"/>
                        </a:solidFill>
                        <a:miter/>
                        <a:tailEnd len="med" type="triangle" w="med"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83" name="AutoShape 7"/>
                      <p:cNvSpPr/>
                      <p:nvPr/>
                    </p:nvSpPr>
                    <p:spPr>
                      <a:xfrm>
                        <a:off x="2165400" y="5253480"/>
                        <a:ext cx="4793760" cy="817200"/>
                      </a:xfrm>
                      <a:prstGeom prst="diamond">
                        <a:avLst/>
                      </a:prstGeom>
                      <a:gradFill rotWithShape="0">
                        <a:gsLst>
                          <a:gs pos="0">
                            <a:srgbClr val="fff200"/>
                          </a:gs>
                          <a:gs pos="100000">
                            <a:srgbClr val="4d0808"/>
                          </a:gs>
                        </a:gsLst>
                        <a:lin ang="4800000"/>
                      </a:gradFill>
                      <a:ln w="0">
                        <a:noFill/>
                      </a:ln>
                      <a:effectLst>
                        <a:outerShdw dist="20160" dir="5400000" blurRad="0" rotWithShape="0">
                          <a:srgbClr val="000000">
                            <a:alpha val="38000"/>
                          </a:srgbClr>
                        </a:outerShdw>
                      </a:effectLst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90000" rIns="90000" tIns="46800" bIns="46800" anchor="ctr">
                        <a:noAutofit/>
                      </a:bodyPr>
                      <a:p>
                        <a:pPr algn="ctr"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1" lang="en-GB" sz="16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Floral Development Pathway</a:t>
                        </a:r>
                        <a:endParaRPr b="0" lang="en-US" sz="16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84" name="AutoShape 20"/>
                      <p:cNvSpPr/>
                      <p:nvPr/>
                    </p:nvSpPr>
                    <p:spPr>
                      <a:xfrm>
                        <a:off x="3414960" y="4728600"/>
                        <a:ext cx="603720" cy="389520"/>
                      </a:xfrm>
                      <a:prstGeom prst="roundRect">
                        <a:avLst>
                          <a:gd name="adj" fmla="val 16667"/>
                        </a:avLst>
                      </a:prstGeom>
                      <a:gradFill rotWithShape="0">
                        <a:gsLst>
                          <a:gs pos="0">
                            <a:srgbClr val="fff200"/>
                          </a:gs>
                          <a:gs pos="100000">
                            <a:srgbClr val="4d0808"/>
                          </a:gs>
                        </a:gsLst>
                        <a:lin ang="4800000"/>
                      </a:gra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90000" rIns="90000" tIns="46800" bIns="46800" anchor="ctr">
                        <a:no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1" lang="en-GB" sz="1400" spc="-1" strike="noStrike">
                            <a:solidFill>
                              <a:srgbClr val="000000"/>
                            </a:solidFill>
                            <a:latin typeface="Calibri"/>
                          </a:rPr>
                          <a:t>SOC1</a:t>
                        </a:r>
                        <a:endParaRPr b="0" lang="en-US" sz="1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85" name="AutoShape 20"/>
                      <p:cNvSpPr/>
                      <p:nvPr/>
                    </p:nvSpPr>
                    <p:spPr>
                      <a:xfrm>
                        <a:off x="4286880" y="4728600"/>
                        <a:ext cx="603720" cy="389520"/>
                      </a:xfrm>
                      <a:prstGeom prst="roundRect">
                        <a:avLst>
                          <a:gd name="adj" fmla="val 16667"/>
                        </a:avLst>
                      </a:prstGeom>
                      <a:gradFill rotWithShape="0">
                        <a:gsLst>
                          <a:gs pos="0">
                            <a:srgbClr val="fff200"/>
                          </a:gs>
                          <a:gs pos="100000">
                            <a:srgbClr val="4d0808"/>
                          </a:gs>
                        </a:gsLst>
                        <a:lin ang="4800000"/>
                      </a:gra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90000" rIns="90000" tIns="46800" bIns="46800" anchor="ctr">
                        <a:no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1" lang="en-GB" sz="1400" spc="-1" strike="noStrike">
                            <a:solidFill>
                              <a:srgbClr val="000000"/>
                            </a:solidFill>
                            <a:latin typeface="Calibri"/>
                          </a:rPr>
                          <a:t>FT1</a:t>
                        </a:r>
                        <a:endParaRPr b="0" lang="en-US" sz="1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86" name="AutoShape 20"/>
                      <p:cNvSpPr/>
                      <p:nvPr/>
                    </p:nvSpPr>
                    <p:spPr>
                      <a:xfrm>
                        <a:off x="5091840" y="4728600"/>
                        <a:ext cx="603720" cy="389520"/>
                      </a:xfrm>
                      <a:prstGeom prst="roundRect">
                        <a:avLst>
                          <a:gd name="adj" fmla="val 16667"/>
                        </a:avLst>
                      </a:prstGeom>
                      <a:gradFill rotWithShape="0">
                        <a:gsLst>
                          <a:gs pos="0">
                            <a:srgbClr val="fff200"/>
                          </a:gs>
                          <a:gs pos="100000">
                            <a:srgbClr val="4d0808"/>
                          </a:gs>
                        </a:gsLst>
                        <a:lin ang="4800000"/>
                      </a:gra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90000" rIns="90000" tIns="46800" bIns="46800" anchor="ctr">
                        <a:no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1" lang="en-GB" sz="1400" spc="-1" strike="noStrike">
                            <a:solidFill>
                              <a:srgbClr val="000000"/>
                            </a:solidFill>
                            <a:latin typeface="Calibri"/>
                          </a:rPr>
                          <a:t>FLC1</a:t>
                        </a:r>
                        <a:endParaRPr b="0" lang="en-US" sz="1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87" name="AutoShape 20"/>
                      <p:cNvSpPr/>
                      <p:nvPr/>
                    </p:nvSpPr>
                    <p:spPr>
                      <a:xfrm>
                        <a:off x="5897160" y="4728600"/>
                        <a:ext cx="603720" cy="389520"/>
                      </a:xfrm>
                      <a:prstGeom prst="roundRect">
                        <a:avLst>
                          <a:gd name="adj" fmla="val 16667"/>
                        </a:avLst>
                      </a:prstGeom>
                      <a:gradFill rotWithShape="0">
                        <a:gsLst>
                          <a:gs pos="0">
                            <a:srgbClr val="fff200"/>
                          </a:gs>
                          <a:gs pos="100000">
                            <a:srgbClr val="4d0808"/>
                          </a:gs>
                        </a:gsLst>
                        <a:lin ang="4800000"/>
                      </a:gra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90000" rIns="90000" tIns="46800" bIns="46800" anchor="ctr">
                        <a:noAutofit/>
                      </a:bodyPr>
                      <a:p>
                        <a:pPr algn="ctr">
                          <a:lnSpc>
                            <a:spcPct val="100000"/>
                          </a:lnSpc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1" lang="en-GB" sz="1400" spc="-1" strike="noStrike">
                            <a:solidFill>
                              <a:srgbClr val="000000"/>
                            </a:solidFill>
                            <a:latin typeface="Calibri"/>
                          </a:rPr>
                          <a:t>FT4</a:t>
                        </a:r>
                        <a:endParaRPr b="0" lang="en-US" sz="1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</p:grpSp>
              </p:grpSp>
            </p:grpSp>
            <p:sp>
              <p:nvSpPr>
                <p:cNvPr id="88" name="AutoShape 6"/>
                <p:cNvSpPr/>
                <p:nvPr/>
              </p:nvSpPr>
              <p:spPr>
                <a:xfrm>
                  <a:off x="5891040" y="2387160"/>
                  <a:ext cx="1204200" cy="365760"/>
                </a:xfrm>
                <a:prstGeom prst="flowChartMagneticDisk">
                  <a:avLst/>
                </a:prstGeom>
                <a:solidFill>
                  <a:srgbClr val="a6a6a6"/>
                </a:solidFill>
                <a:ln w="0">
                  <a:noFill/>
                </a:ln>
                <a:effectLst>
                  <a:outerShdw dist="20160" dir="5400000" blurRad="0" rotWithShape="0">
                    <a:srgbClr val="000000">
                      <a:alpha val="38000"/>
                    </a:srgbClr>
                  </a:outerShdw>
                </a:effectLst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10080" bIns="14616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600" spc="-1" strike="noStrike">
                      <a:solidFill>
                        <a:srgbClr val="000000"/>
                      </a:solidFill>
                      <a:latin typeface="Arial"/>
                    </a:rPr>
                    <a:t>Annexin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" name="Line 48"/>
                <p:cNvSpPr/>
                <p:nvPr/>
              </p:nvSpPr>
              <p:spPr>
                <a:xfrm flipV="1">
                  <a:off x="5308200" y="2809080"/>
                  <a:ext cx="506880" cy="350640"/>
                </a:xfrm>
                <a:prstGeom prst="line">
                  <a:avLst/>
                </a:prstGeom>
                <a:ln w="2844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" name="Line 27"/>
                <p:cNvSpPr/>
                <p:nvPr/>
              </p:nvSpPr>
              <p:spPr>
                <a:xfrm>
                  <a:off x="6472800" y="2816280"/>
                  <a:ext cx="0" cy="192240"/>
                </a:xfrm>
                <a:prstGeom prst="line">
                  <a:avLst/>
                </a:prstGeom>
                <a:ln w="2844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91" name="AutoShape 44"/>
              <p:cNvSpPr/>
              <p:nvPr/>
            </p:nvSpPr>
            <p:spPr>
              <a:xfrm>
                <a:off x="4065120" y="1893240"/>
                <a:ext cx="938520" cy="340560"/>
              </a:xfrm>
              <a:prstGeom prst="flowChartMagneticDisk">
                <a:avLst/>
              </a:prstGeom>
              <a:solidFill>
                <a:srgbClr val="4bacc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3240" bIns="13284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600" spc="-1" strike="noStrike">
                    <a:solidFill>
                      <a:srgbClr val="000000"/>
                    </a:solidFill>
                    <a:latin typeface="Arial"/>
                  </a:rPr>
                  <a:t>PIN1/2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AutoShape 44"/>
              <p:cNvSpPr/>
              <p:nvPr/>
            </p:nvSpPr>
            <p:spPr>
              <a:xfrm>
                <a:off x="4065120" y="1341360"/>
                <a:ext cx="938520" cy="338760"/>
              </a:xfrm>
              <a:prstGeom prst="flowChartMagneticDisk">
                <a:avLst/>
              </a:prstGeom>
              <a:solidFill>
                <a:srgbClr val="4bacc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3960" bIns="13212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600" spc="-1" strike="noStrike">
                    <a:solidFill>
                      <a:srgbClr val="000000"/>
                    </a:solidFill>
                    <a:latin typeface="Arial"/>
                  </a:rPr>
                  <a:t>Auxin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93" name="AutoShape 20"/>
          <p:cNvSpPr/>
          <p:nvPr/>
        </p:nvSpPr>
        <p:spPr>
          <a:xfrm>
            <a:off x="3679920" y="3962520"/>
            <a:ext cx="1944720" cy="360360"/>
          </a:xfrm>
          <a:prstGeom prst="roundRect">
            <a:avLst>
              <a:gd name="adj" fmla="val 16667"/>
            </a:avLst>
          </a:prstGeom>
          <a:gradFill rotWithShape="0">
            <a:gsLst>
              <a:gs pos="0">
                <a:srgbClr val="a07400"/>
              </a:gs>
              <a:gs pos="100000">
                <a:srgbClr val="ffca00"/>
              </a:gs>
            </a:gsLst>
            <a:lin ang="48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rp2/3 complex; </a:t>
            </a: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ARP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7-28T18:50:42Z</dcterms:created>
  <dc:creator>Bhupendra Chaudhary</dc:creator>
  <dc:description/>
  <dc:language>en-US</dc:language>
  <cp:lastModifiedBy>Bhupendra Chaudhary</cp:lastModifiedBy>
  <dcterms:modified xsi:type="dcterms:W3CDTF">2020-11-11T11:04:08Z</dcterms:modified>
  <cp:revision>7</cp:revision>
  <dc:subject/>
  <dc:title>Slide 1</dc:title>
</cp:coreProperties>
</file>